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B4C523-C6C9-E84D-9FF7-9D14FE7F2955}" type="datetimeFigureOut">
              <a:rPr lang="en-US" smtClean="0"/>
              <a:t>6/19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3855E4-30DB-2D48-895D-35003EF484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570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S1 Tab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3855E4-30DB-2D48-895D-35003EF4846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9336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88F2C-0679-0647-9F96-51825F2915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FE6C46-5D80-6640-916E-1B8429B0B0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CF017C-5E25-7945-98A9-5CCEBDA2A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40E857-4482-3C42-A360-8D5BC3D87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FBDE3E-1568-6E4E-BFA3-E5896B488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64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D0798-2AAC-4348-AC77-3DB14482C2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A1A39D-2919-DC41-B869-F065DB2FEE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6F889B-C0C9-3049-9AA1-A5E4DFCD3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C034DB-A8AA-0047-899A-92A0F2930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F18BFD-AC3C-E540-9A39-6CF1AFF29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131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39B07D-D74A-A345-A2CA-7973B2D914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43F48C-549B-8D4B-89F0-82703486B7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3BF471-E883-774E-8A07-C5A86B6EB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C4541E-AA8E-6741-80FE-C6B70A2D6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AEC4FE-E99F-074E-9261-E6AF58906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930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9FACA-75C8-5243-808E-991484E75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4CB953-B7EE-5F4F-A961-205DB158AD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F98252-E2DB-6946-AFA3-F0520BD9D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9BDBBC-0B1C-2B4D-AA35-F70240EF4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8B4CD6-D319-E449-B429-067FB6DA4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436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F94A89-70B8-4B4C-BD24-974E16D6EC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18BD33-0D46-8E40-B2CE-B0363F6D27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D1BA25-FCCD-FF41-984A-90AC4A63E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1815B6-DC99-A448-8CA4-792986528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3A64D4-4C5B-BC4B-9985-7F65B1967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821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2FB5F-820C-AE42-AEE6-202932C40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B03A4B-AE60-C64E-85EE-42E1592628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FE3C37-7980-1947-BE03-B5FF06733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7CDCAF-2035-634F-AAF6-4699220F6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A5D9B3-D416-AE46-B2A1-C497368EB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EC98FA-00E1-554A-BCDE-80740897D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550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02F82-3775-9147-90C6-9DD79095BD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CD837F-6E61-1544-B4D2-E51E825D2B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AE9E5A-0FC5-CF4B-BC75-AF87ED9793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506B81-5B9E-F048-BDE6-894DC0FB07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F30305-0D37-E247-83E9-56978709C5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C92238-D304-0247-849E-E00F046A0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BBB34FB-7C02-A74D-80CE-DBD3EAF85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623E06-9B51-504E-9C84-74C600B90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535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A851D4-A780-3B49-ACDD-E2FAFD5C68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A26BB1-8B11-444C-987E-1060E465B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03AC14-58B7-A340-B35D-0A1129C28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64F2DC-1696-7F40-8050-0C7145C61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109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9B8AA9-FFCD-944B-AA28-47B2012A7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893C60-8227-874E-BB46-D9DD290A6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C6BB333-29A5-CB4B-A852-18209A5FC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309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1D965-ED62-B247-9AC2-B902E04B8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DFFB38-77B1-D247-96D5-68C15B439C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8D9E16-9E87-1E4C-A88B-8DD787BB7D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05CF33-8042-F442-A7C1-9C4E5088C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3CD515-B2F7-F84B-B898-211C87AE2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634039-1C5F-1844-8AB3-1AA3912BF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426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515DA6-FC8D-8F41-A3B2-0AA5F6F8C9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378B6F-4D17-DA4B-9902-2CED0DA315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2902C2-B187-D145-8A0C-C90E2D61EA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698ECB-DE3E-C44D-A7CB-F7ED17CA4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45642F-EB7D-B349-8964-6A922E2B2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FF2DF6-6323-0246-937D-C137C10C6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49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EC2ABF-645E-9A44-80D5-CFE559847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1BE37B-2EDF-4446-A904-8535B0055D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885E0C-8E6F-7D49-A9C0-7AC7D90190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A4DFF-AC27-8A49-BD30-3D7DA7D4ED38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D6DF69-6127-A143-84DA-D7C33B97D4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0B967-70C1-0245-83A7-51D6F0FE66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5CA65-9C9E-044B-B053-7BEF595CF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32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075B152-0AEB-3848-A4A8-5728F21E02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649921"/>
              </p:ext>
            </p:extLst>
          </p:nvPr>
        </p:nvGraphicFramePr>
        <p:xfrm>
          <a:off x="431075" y="1120503"/>
          <a:ext cx="11277600" cy="391628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45447">
                  <a:extLst>
                    <a:ext uri="{9D8B030D-6E8A-4147-A177-3AD203B41FA5}">
                      <a16:colId xmlns:a16="http://schemas.microsoft.com/office/drawing/2014/main" val="68600948"/>
                    </a:ext>
                  </a:extLst>
                </a:gridCol>
                <a:gridCol w="2082302">
                  <a:extLst>
                    <a:ext uri="{9D8B030D-6E8A-4147-A177-3AD203B41FA5}">
                      <a16:colId xmlns:a16="http://schemas.microsoft.com/office/drawing/2014/main" val="2779428323"/>
                    </a:ext>
                  </a:extLst>
                </a:gridCol>
                <a:gridCol w="2082302">
                  <a:extLst>
                    <a:ext uri="{9D8B030D-6E8A-4147-A177-3AD203B41FA5}">
                      <a16:colId xmlns:a16="http://schemas.microsoft.com/office/drawing/2014/main" val="2415409590"/>
                    </a:ext>
                  </a:extLst>
                </a:gridCol>
                <a:gridCol w="5067549">
                  <a:extLst>
                    <a:ext uri="{9D8B030D-6E8A-4147-A177-3AD203B41FA5}">
                      <a16:colId xmlns:a16="http://schemas.microsoft.com/office/drawing/2014/main" val="51206703"/>
                    </a:ext>
                  </a:extLst>
                </a:gridCol>
              </a:tblGrid>
              <a:tr h="317503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the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havio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6729360"/>
                  </a:ext>
                </a:extLst>
              </a:tr>
              <a:tr h="1017749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Allee effe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 = intrinsic growth rat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s exhibit cell autonomous proliferation and will grow at a constant rate regardless of cell numb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8150020"/>
                  </a:ext>
                </a:extLst>
              </a:tr>
              <a:tr h="1252614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ng Allee effe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= Allee threshold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 the number of cells is below the threshold A, the population will go extinct. If N is near A, the growth rate will be slowed until N&gt;&gt;A when the growth rate will approach 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5890816"/>
                  </a:ext>
                </a:extLst>
              </a:tr>
              <a:tr h="1252614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ak/strong Allee effe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𝞃 </a:t>
                      </a:r>
                      <a:r>
                        <a:rPr lang="en-US" sz="16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</a:t>
                      </a: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all shape parameter, as 𝞃 increases, per capita growth flattens</a:t>
                      </a:r>
                    </a:p>
                    <a:p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en A is positive, strong Allee effect, when 𝞃&gt;|A| and A is negative, the population will grow more slowly when N is near A, but will not go extin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8496129"/>
                  </a:ext>
                </a:extLst>
              </a:tr>
            </a:tbl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FBE63FA-431B-934B-86B7-C97F74706D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4939415"/>
              </p:ext>
            </p:extLst>
          </p:nvPr>
        </p:nvGraphicFramePr>
        <p:xfrm>
          <a:off x="2783884" y="1517916"/>
          <a:ext cx="1170612" cy="751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r:id="rId4" imgW="317500" imgH="203200" progId="Equation.DSMT4">
                  <p:embed/>
                </p:oleObj>
              </mc:Choice>
              <mc:Fallback>
                <p:oleObj r:id="rId4" imgW="317500" imgH="203200" progId="Equation.DSMT4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0AACB69-9E36-9442-B7B4-04A44FFFD3A5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83884" y="1517916"/>
                        <a:ext cx="1170612" cy="75114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525D86C-65B0-2D45-BFB5-D78910BCB6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603256"/>
              </p:ext>
            </p:extLst>
          </p:nvPr>
        </p:nvGraphicFramePr>
        <p:xfrm>
          <a:off x="2648359" y="2674022"/>
          <a:ext cx="1836602" cy="699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6" imgW="533400" imgH="203200" progId="Equation.DSMT4">
                  <p:embed/>
                </p:oleObj>
              </mc:Choice>
              <mc:Fallback>
                <p:oleObj r:id="rId6" imgW="533400" imgH="203200" progId="Equation.DSMT4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52D4E42-602B-954C-A605-E11084C8514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48359" y="2674022"/>
                        <a:ext cx="1836602" cy="69919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4CDA3B6B-0F90-FB41-8309-02D70745B0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5979763"/>
              </p:ext>
            </p:extLst>
          </p:nvPr>
        </p:nvGraphicFramePr>
        <p:xfrm>
          <a:off x="2535710" y="4060022"/>
          <a:ext cx="1821385" cy="5711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r:id="rId8" imgW="647700" imgH="203200" progId="Equation.DSMT4">
                  <p:embed/>
                </p:oleObj>
              </mc:Choice>
              <mc:Fallback>
                <p:oleObj r:id="rId8" imgW="647700" imgH="203200" progId="Equation.DSMT4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A29C358-B970-E649-A988-C1315638AA1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35710" y="4060022"/>
                        <a:ext cx="1821385" cy="57118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61835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Macintosh PowerPoint</Application>
  <PresentationFormat>Widescreen</PresentationFormat>
  <Paragraphs>1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Equation.DSMT4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Kaitlyn</dc:creator>
  <cp:lastModifiedBy>Johnson, Kaitlyn</cp:lastModifiedBy>
  <cp:revision>1</cp:revision>
  <dcterms:created xsi:type="dcterms:W3CDTF">2019-06-13T21:47:30Z</dcterms:created>
  <dcterms:modified xsi:type="dcterms:W3CDTF">2019-06-19T22:15:46Z</dcterms:modified>
</cp:coreProperties>
</file>